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094692\OneDrive%20for%20Business\0_Theme\0_EML4-ALK%20IHC\Paper\ALK37%20cell%20line%20RT-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21226788180713"/>
          <c:y val="8.4622985156543151E-2"/>
          <c:w val="0.65930975457153318"/>
          <c:h val="0.75230213964116632"/>
        </c:manualLayout>
      </c:layout>
      <c:lineChart>
        <c:grouping val="standard"/>
        <c:varyColors val="0"/>
        <c:ser>
          <c:idx val="0"/>
          <c:order val="0"/>
          <c:tx>
            <c:strRef>
              <c:f>Fusion纏め!$B$6</c:f>
              <c:strCache>
                <c:ptCount val="1"/>
                <c:pt idx="0">
                  <c:v>NCI-H222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6:$I$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2.4099999999999998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usion纏め!$B$7</c:f>
              <c:strCache>
                <c:ptCount val="1"/>
                <c:pt idx="0">
                  <c:v>SNU-2535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rgbClr val="FF00FF"/>
              </a:solidFill>
              <a:ln w="9525">
                <a:solidFill>
                  <a:srgbClr val="FF00FF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7:$I$7</c:f>
              <c:numCache>
                <c:formatCode>General</c:formatCode>
                <c:ptCount val="7"/>
                <c:pt idx="0">
                  <c:v>1.0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usion纏め!$B$8</c:f>
              <c:strCache>
                <c:ptCount val="1"/>
                <c:pt idx="0">
                  <c:v>SNU-2292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8:$I$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2.0500000000000002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usion纏め!$B$9</c:f>
              <c:strCache>
                <c:ptCount val="1"/>
                <c:pt idx="0">
                  <c:v>HCC827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9:$I$9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Fusion纏め!$B$10</c:f>
              <c:strCache>
                <c:ptCount val="1"/>
                <c:pt idx="0">
                  <c:v>PC-9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0:$I$1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Fusion纏め!$B$11</c:f>
              <c:strCache>
                <c:ptCount val="1"/>
                <c:pt idx="0">
                  <c:v>B901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1:$I$11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Fusion纏め!$B$12</c:f>
              <c:strCache>
                <c:ptCount val="1"/>
                <c:pt idx="0">
                  <c:v>HCC4006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2:$I$1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Fusion纏め!$B$13</c:f>
              <c:strCache>
                <c:ptCount val="1"/>
                <c:pt idx="0">
                  <c:v>HCC2935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3:$I$13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Fusion纏め!$B$14</c:f>
              <c:strCache>
                <c:ptCount val="1"/>
                <c:pt idx="0">
                  <c:v>PC-3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4:$I$14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Fusion纏め!$B$15</c:f>
              <c:strCache>
                <c:ptCount val="1"/>
                <c:pt idx="0">
                  <c:v>NCI-H1650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5:$I$15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Fusion纏め!$B$16</c:f>
              <c:strCache>
                <c:ptCount val="1"/>
                <c:pt idx="0">
                  <c:v>II-1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6:$I$1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Fusion纏め!$B$17</c:f>
              <c:strCache>
                <c:ptCount val="1"/>
                <c:pt idx="0">
                  <c:v>NCI-H1975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7:$I$17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2"/>
          <c:order val="12"/>
          <c:tx>
            <c:strRef>
              <c:f>Fusion纏め!$B$18</c:f>
              <c:strCache>
                <c:ptCount val="1"/>
                <c:pt idx="0">
                  <c:v>NCI-H820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8:$I$1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3"/>
          <c:order val="13"/>
          <c:tx>
            <c:strRef>
              <c:f>Fusion纏め!$B$19</c:f>
              <c:strCache>
                <c:ptCount val="1"/>
                <c:pt idx="0">
                  <c:v>Calu-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solidFill>
                  <a:schemeClr val="accent2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19:$I$19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4"/>
          <c:order val="14"/>
          <c:tx>
            <c:strRef>
              <c:f>Fusion纏め!$B$20</c:f>
              <c:strCache>
                <c:ptCount val="1"/>
                <c:pt idx="0">
                  <c:v>NCI-H35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  <a:lumOff val="20000"/>
                </a:schemeClr>
              </a:solidFill>
              <a:ln w="9525">
                <a:solidFill>
                  <a:schemeClr val="accent3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0:$I$2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5"/>
          <c:order val="15"/>
          <c:tx>
            <c:strRef>
              <c:f>Fusion纏め!$B$21</c:f>
              <c:strCache>
                <c:ptCount val="1"/>
                <c:pt idx="0">
                  <c:v>HOP-62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  <a:lumOff val="20000"/>
                </a:schemeClr>
              </a:solidFill>
              <a:ln w="9525">
                <a:solidFill>
                  <a:schemeClr val="accent4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1:$I$21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6"/>
          <c:order val="16"/>
          <c:tx>
            <c:strRef>
              <c:f>Fusion纏め!$B$22</c:f>
              <c:strCache>
                <c:ptCount val="1"/>
                <c:pt idx="0">
                  <c:v>NCI-H2122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80000"/>
                  <a:lumOff val="20000"/>
                </a:schemeClr>
              </a:solidFill>
              <a:ln w="9525">
                <a:solidFill>
                  <a:schemeClr val="accent5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2:$I$2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7"/>
          <c:order val="17"/>
          <c:tx>
            <c:strRef>
              <c:f>Fusion纏め!$B$23</c:f>
              <c:strCache>
                <c:ptCount val="1"/>
                <c:pt idx="0">
                  <c:v>Calu-6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3:$I$23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8"/>
          <c:order val="18"/>
          <c:tx>
            <c:strRef>
              <c:f>Fusion纏め!$B$24</c:f>
              <c:strCache>
                <c:ptCount val="1"/>
                <c:pt idx="0">
                  <c:v>NCI-H460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</a:schemeClr>
              </a:solidFill>
              <a:ln w="9525">
                <a:solidFill>
                  <a:schemeClr val="accent1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4:$I$24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19"/>
          <c:order val="19"/>
          <c:tx>
            <c:strRef>
              <c:f>Fusion纏め!$B$25</c:f>
              <c:strCache>
                <c:ptCount val="1"/>
                <c:pt idx="0">
                  <c:v>NCI-H596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5:$I$25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0"/>
          <c:order val="20"/>
          <c:tx>
            <c:strRef>
              <c:f>Fusion纏め!$B$26</c:f>
              <c:strCache>
                <c:ptCount val="1"/>
                <c:pt idx="0">
                  <c:v>NCI-H178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80000"/>
                </a:schemeClr>
              </a:solidFill>
              <a:ln w="9525">
                <a:solidFill>
                  <a:schemeClr val="accent3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6:$I$2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1"/>
          <c:order val="21"/>
          <c:tx>
            <c:strRef>
              <c:f>Fusion纏め!$B$27</c:f>
              <c:strCache>
                <c:ptCount val="1"/>
                <c:pt idx="0">
                  <c:v>NCI-H1755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7:$I$27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2"/>
          <c:order val="22"/>
          <c:tx>
            <c:strRef>
              <c:f>Fusion纏め!$B$28</c:f>
              <c:strCache>
                <c:ptCount val="1"/>
                <c:pt idx="0">
                  <c:v>LC-2/ad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chemeClr val="accent5">
                  <a:lumMod val="80000"/>
                </a:schemeClr>
              </a:solidFill>
              <a:ln w="9525">
                <a:solidFill>
                  <a:schemeClr val="accent5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8:$I$2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8700000000000002E-3</c:v>
                </c:pt>
                <c:pt idx="6">
                  <c:v>0</c:v>
                </c:pt>
              </c:numCache>
            </c:numRef>
          </c:val>
          <c:smooth val="0"/>
        </c:ser>
        <c:ser>
          <c:idx val="23"/>
          <c:order val="23"/>
          <c:tx>
            <c:strRef>
              <c:f>Fusion纏め!$B$29</c:f>
              <c:strCache>
                <c:ptCount val="1"/>
                <c:pt idx="0">
                  <c:v>HCC7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chemeClr val="accent6">
                  <a:lumMod val="80000"/>
                </a:schemeClr>
              </a:solidFill>
              <a:ln w="9525">
                <a:solidFill>
                  <a:schemeClr val="accent6">
                    <a:lumMod val="8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29:$I$29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2399999999999998E-3</c:v>
                </c:pt>
              </c:numCache>
            </c:numRef>
          </c:val>
          <c:smooth val="0"/>
        </c:ser>
        <c:ser>
          <c:idx val="24"/>
          <c:order val="24"/>
          <c:tx>
            <c:strRef>
              <c:f>Fusion纏め!$B$30</c:f>
              <c:strCache>
                <c:ptCount val="1"/>
                <c:pt idx="0">
                  <c:v>NCI-H2347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0:$I$3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5"/>
          <c:order val="25"/>
          <c:tx>
            <c:strRef>
              <c:f>Fusion纏め!$B$31</c:f>
              <c:strCache>
                <c:ptCount val="1"/>
                <c:pt idx="0">
                  <c:v>NCI-H1993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1:$I$31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6"/>
          <c:order val="26"/>
          <c:tx>
            <c:strRef>
              <c:f>Fusion纏め!$B$32</c:f>
              <c:strCache>
                <c:ptCount val="1"/>
                <c:pt idx="0">
                  <c:v>NCI-H156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2:$I$3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7"/>
          <c:order val="27"/>
          <c:tx>
            <c:strRef>
              <c:f>Fusion纏め!$B$33</c:f>
              <c:strCache>
                <c:ptCount val="1"/>
                <c:pt idx="0">
                  <c:v>NCI-H522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3:$I$33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8"/>
          <c:order val="28"/>
          <c:tx>
            <c:strRef>
              <c:f>Fusion纏め!$B$34</c:f>
              <c:strCache>
                <c:ptCount val="1"/>
                <c:pt idx="0">
                  <c:v>NCI-H838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4:$I$34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29"/>
          <c:order val="29"/>
          <c:tx>
            <c:strRef>
              <c:f>Fusion纏め!$B$35</c:f>
              <c:strCache>
                <c:ptCount val="1"/>
                <c:pt idx="0">
                  <c:v>A529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5:$I$35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0"/>
          <c:order val="30"/>
          <c:tx>
            <c:strRef>
              <c:f>Fusion纏め!$B$36</c:f>
              <c:strCache>
                <c:ptCount val="1"/>
                <c:pt idx="0">
                  <c:v>NCI-H1703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6:$I$3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1"/>
          <c:order val="31"/>
          <c:tx>
            <c:strRef>
              <c:f>Fusion纏め!$B$37</c:f>
              <c:strCache>
                <c:ptCount val="1"/>
                <c:pt idx="0">
                  <c:v>NCI-H520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7:$I$37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2"/>
          <c:order val="32"/>
          <c:tx>
            <c:strRef>
              <c:f>Fusion纏め!$B$38</c:f>
              <c:strCache>
                <c:ptCount val="1"/>
                <c:pt idx="0">
                  <c:v>NCI-H2170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8:$I$3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3"/>
          <c:order val="33"/>
          <c:tx>
            <c:strRef>
              <c:f>Fusion纏め!$B$39</c:f>
              <c:strCache>
                <c:ptCount val="1"/>
                <c:pt idx="0">
                  <c:v>NCI-H226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39:$I$39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4"/>
          <c:order val="34"/>
          <c:tx>
            <c:strRef>
              <c:f>Fusion纏め!$B$40</c:f>
              <c:strCache>
                <c:ptCount val="1"/>
                <c:pt idx="0">
                  <c:v>SK-MES-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50000"/>
                </a:schemeClr>
              </a:solidFill>
              <a:ln w="9525">
                <a:solidFill>
                  <a:schemeClr val="accent5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40:$I$4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5"/>
          <c:order val="35"/>
          <c:tx>
            <c:strRef>
              <c:f>Fusion纏め!$B$41</c:f>
              <c:strCache>
                <c:ptCount val="1"/>
                <c:pt idx="0">
                  <c:v>NCI-H1915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41:$I$41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ser>
          <c:idx val="36"/>
          <c:order val="36"/>
          <c:tx>
            <c:strRef>
              <c:f>Fusion纏め!$B$42</c:f>
              <c:strCache>
                <c:ptCount val="1"/>
                <c:pt idx="0">
                  <c:v>NCI-H292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20"/>
            <c:spPr>
              <a:solidFill>
                <a:schemeClr val="accent1">
                  <a:lumMod val="70000"/>
                  <a:lumOff val="30000"/>
                </a:schemeClr>
              </a:solidFill>
              <a:ln w="9525">
                <a:solidFill>
                  <a:schemeClr val="accent1">
                    <a:lumMod val="70000"/>
                    <a:lumOff val="30000"/>
                  </a:schemeClr>
                </a:solidFill>
              </a:ln>
              <a:effectLst/>
            </c:spPr>
          </c:marker>
          <c:cat>
            <c:multiLvlStrRef>
              <c:f>Fusion纏め!$C$4:$I$5</c:f>
              <c:multiLvlStrCache>
                <c:ptCount val="7"/>
                <c:lvl>
                  <c:pt idx="0">
                    <c:v>Variant 1</c:v>
                  </c:pt>
                  <c:pt idx="1">
                    <c:v>Variant 2</c:v>
                  </c:pt>
                  <c:pt idx="2">
                    <c:v>Variant 3a</c:v>
                  </c:pt>
                  <c:pt idx="3">
                    <c:v>Variant 3b</c:v>
                  </c:pt>
                </c:lvl>
                <c:lvl>
                  <c:pt idx="0">
                    <c:v>EML4-ALK</c:v>
                  </c:pt>
                  <c:pt idx="4">
                    <c:v>KF5B-RET</c:v>
                  </c:pt>
                  <c:pt idx="5">
                    <c:v>CCDC6-RET</c:v>
                  </c:pt>
                  <c:pt idx="6">
                    <c:v>SLC34A2-ROS1</c:v>
                  </c:pt>
                </c:lvl>
              </c:multiLvlStrCache>
            </c:multiLvlStrRef>
          </c:cat>
          <c:val>
            <c:numRef>
              <c:f>Fusion纏め!$C$42:$I$42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38676736"/>
        <c:axId val="338678304"/>
      </c:lineChart>
      <c:catAx>
        <c:axId val="338676736"/>
        <c:scaling>
          <c:orientation val="minMax"/>
        </c:scaling>
        <c:delete val="0"/>
        <c:axPos val="b"/>
        <c:numFmt formatCode="General" sourceLinked="1"/>
        <c:majorTickMark val="out"/>
        <c:minorTickMark val="in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38678304"/>
        <c:crosses val="autoZero"/>
        <c:auto val="1"/>
        <c:lblAlgn val="ctr"/>
        <c:lblOffset val="100"/>
        <c:tickMarkSkip val="1"/>
        <c:noMultiLvlLbl val="0"/>
      </c:catAx>
      <c:valAx>
        <c:axId val="338678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RNA expression</a:t>
                </a:r>
              </a:p>
            </c:rich>
          </c:tx>
          <c:layout>
            <c:manualLayout>
              <c:xMode val="edge"/>
              <c:yMode val="edge"/>
              <c:x val="2.2741294415914106E-4"/>
              <c:y val="0.367841716518263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38676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1609918245524"/>
          <c:y val="8.6138879565708551E-4"/>
          <c:w val="0.12958728388753366"/>
          <c:h val="0.999138658672497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7741882"/>
              </p:ext>
            </p:extLst>
          </p:nvPr>
        </p:nvGraphicFramePr>
        <p:xfrm>
          <a:off x="1860550" y="693967"/>
          <a:ext cx="8470900" cy="56769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0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790370" y="137523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U-2535</a:t>
            </a:r>
            <a:endParaRPr kumimoji="1" lang="ja-JP" altLang="en-US" sz="1200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305299" y="4023280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I-H2228</a:t>
            </a:r>
            <a:endParaRPr kumimoji="1" lang="ja-JP" alt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374227" y="4796973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U-2292</a:t>
            </a:r>
            <a:endParaRPr kumimoji="1"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879772" y="3532418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accent5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C-2/ad</a:t>
            </a:r>
            <a:endParaRPr kumimoji="1" lang="ja-JP" altLang="en-US" sz="1200" dirty="0">
              <a:solidFill>
                <a:schemeClr val="accent5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750631" y="414202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accent6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CC78</a:t>
            </a:r>
            <a:endParaRPr kumimoji="1" lang="ja-JP" altLang="en-US" sz="1200" dirty="0">
              <a:solidFill>
                <a:schemeClr val="accent6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5036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10</Words>
  <Application>Microsoft Office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6</cp:revision>
  <cp:lastPrinted>2017-03-13T01:57:05Z</cp:lastPrinted>
  <dcterms:created xsi:type="dcterms:W3CDTF">2016-11-14T09:26:54Z</dcterms:created>
  <dcterms:modified xsi:type="dcterms:W3CDTF">2017-09-22T13:47:58Z</dcterms:modified>
</cp:coreProperties>
</file>